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5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966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233" autoAdjust="0"/>
    <p:restoredTop sz="96076" autoAdjust="0"/>
  </p:normalViewPr>
  <p:slideViewPr>
    <p:cSldViewPr snapToGrid="0">
      <p:cViewPr varScale="1">
        <p:scale>
          <a:sx n="62" d="100"/>
          <a:sy n="62" d="100"/>
        </p:scale>
        <p:origin x="264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161C01-9F1A-4548-8453-A45B4743FB18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069ED27-3606-498C-8CFF-22451B4E05B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088682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1336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526247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971997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189586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298208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804227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405095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069187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892056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254867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755973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579990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71FFBF62-4C20-4CFA-805B-719E418BC132}"/>
              </a:ext>
            </a:extLst>
          </p:cNvPr>
          <p:cNvSpPr/>
          <p:nvPr/>
        </p:nvSpPr>
        <p:spPr>
          <a:xfrm>
            <a:off x="288275" y="6811273"/>
            <a:ext cx="5883925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file 3: Figure S3.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ermination curves of primary dormant tomato seeds from different genotypes during imbibition in water at 20°C in </a:t>
            </a:r>
            <a:r>
              <a:rPr lang="en-US" sz="110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dark. </a:t>
            </a:r>
            <a:r>
              <a:rPr lang="en-GB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ints represent the germination percentage and was determined on 60 seeds. </a:t>
            </a:r>
            <a:endParaRPr lang="fr-FR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D2DABBBE-3AD5-4B62-861C-CADA4C3C4A3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0754" y="2674620"/>
            <a:ext cx="5015676" cy="38938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84124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98</TotalTime>
  <Words>41</Words>
  <Application>Microsoft Office PowerPoint</Application>
  <PresentationFormat>Format A4 (210 x 297 mm)</PresentationFormat>
  <Paragraphs>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Hubert</dc:creator>
  <cp:lastModifiedBy>Julia Buitink</cp:lastModifiedBy>
  <cp:revision>109</cp:revision>
  <dcterms:created xsi:type="dcterms:W3CDTF">2023-08-10T14:53:51Z</dcterms:created>
  <dcterms:modified xsi:type="dcterms:W3CDTF">2024-01-17T14:50:37Z</dcterms:modified>
</cp:coreProperties>
</file>